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ECD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458" autoAdjust="0"/>
    <p:restoredTop sz="96735" autoAdjust="0"/>
  </p:normalViewPr>
  <p:slideViewPr>
    <p:cSldViewPr snapToGrid="0">
      <p:cViewPr>
        <p:scale>
          <a:sx n="110" d="100"/>
          <a:sy n="110" d="100"/>
        </p:scale>
        <p:origin x="684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7A5621-B5F2-4D24-9D9A-F0EDCC662AD3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A8CDF7-50F7-44AE-90AC-E25E60832A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1E5050-822A-493B-A898-D4E4954C0718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47D9C-1528-42A1-9CC9-54538D8F5E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9285751"/>
              </p:ext>
            </p:extLst>
          </p:nvPr>
        </p:nvGraphicFramePr>
        <p:xfrm>
          <a:off x="299118" y="207586"/>
          <a:ext cx="5778500" cy="3781425"/>
        </p:xfrm>
        <a:graphic>
          <a:graphicData uri="http://schemas.openxmlformats.org/drawingml/2006/table">
            <a:tbl>
              <a:tblPr/>
              <a:tblGrid>
                <a:gridCol w="12185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133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566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9005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2387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Supplementary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Table S1: Variable importance in projection and correlation coefficients assessment of significant metabolites and ratio between control and asthma in an OPLS-DA model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la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orr.Coeffs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Ratio of Ornithine/L-Argin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.80E-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Ratio of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itrulline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/Ornith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adip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4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Organic Aci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Malic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.0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Organic Aci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umar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.1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L-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rabito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.9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L-Argin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2.6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Organic Aci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Pyrophosph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2.8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Ratio of Pyruvic acid/L-Alan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3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itrulli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Sorbit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5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L-Arabino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7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D-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Threito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9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atty Aci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Tetracosanoic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3.9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atty Aci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Palmitole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-0.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4.2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mino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Alpha-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ketoisovaler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4.8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Ribonolacto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4.4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43</Words>
  <Application>Microsoft Office PowerPoint</Application>
  <PresentationFormat>On-screen Show (4:3)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折剑青</dc:creator>
  <cp:lastModifiedBy>MDPI</cp:lastModifiedBy>
  <cp:revision>90</cp:revision>
  <dcterms:created xsi:type="dcterms:W3CDTF">2018-10-30T02:57:00Z</dcterms:created>
  <dcterms:modified xsi:type="dcterms:W3CDTF">2021-11-17T08:33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2BB9F773564471FA40FE23C266DD98F</vt:lpwstr>
  </property>
  <property fmtid="{D5CDD505-2E9C-101B-9397-08002B2CF9AE}" pid="3" name="KSOProductBuildVer">
    <vt:lpwstr>2052-11.1.0.11045</vt:lpwstr>
  </property>
</Properties>
</file>